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0" r:id="rId2"/>
    <p:sldId id="297" r:id="rId3"/>
    <p:sldId id="267" r:id="rId4"/>
    <p:sldId id="293" r:id="rId5"/>
    <p:sldId id="295" r:id="rId6"/>
  </p:sldIdLst>
  <p:sldSz cx="12192000" cy="6858000"/>
  <p:notesSz cx="7053263" cy="93567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ice Patterson" initials="JP" lastIdx="3" clrIdx="0">
    <p:extLst/>
  </p:cmAuthor>
  <p:cmAuthor id="2" name="Mike Heinrich" initials="MH" lastIdx="3" clrIdx="1">
    <p:extLst>
      <p:ext uri="{19B8F6BF-5375-455C-9EA6-DF929625EA0E}">
        <p15:presenceInfo xmlns:p15="http://schemas.microsoft.com/office/powerpoint/2012/main" userId="4452a4dba3b51603" providerId="Windows Live"/>
      </p:ext>
    </p:extLst>
  </p:cmAuthor>
  <p:cmAuthor id="3" name="janice" initials="MOU" lastIdx="1" clrIdx="2">
    <p:extLst>
      <p:ext uri="{19B8F6BF-5375-455C-9EA6-DF929625EA0E}">
        <p15:presenceInfo xmlns:p15="http://schemas.microsoft.com/office/powerpoint/2012/main" userId="janice" providerId="None"/>
      </p:ext>
    </p:extLst>
  </p:cmAuthor>
  <p:cmAuthor id="4" name="Michael Heinrich" initials="MH" lastIdx="5" clrIdx="3">
    <p:extLst>
      <p:ext uri="{19B8F6BF-5375-455C-9EA6-DF929625EA0E}">
        <p15:presenceInfo xmlns:p15="http://schemas.microsoft.com/office/powerpoint/2012/main" userId="S-1-5-21-1366901343-1712286707-620655208-1495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9301" autoAdjust="0"/>
    <p:restoredTop sz="91429" autoAdjust="0"/>
  </p:normalViewPr>
  <p:slideViewPr>
    <p:cSldViewPr snapToGrid="0">
      <p:cViewPr varScale="1">
        <p:scale>
          <a:sx n="69" d="100"/>
          <a:sy n="69" d="100"/>
        </p:scale>
        <p:origin x="208" y="9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patterja\Box%20Sync\Heinrich%20Lab\GIST_Analysis\table_maker\Breakdown_of_mutations_by_sample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r>
              <a:rPr lang="en-US">
                <a:solidFill>
                  <a:schemeClr val="tx1"/>
                </a:solidFill>
              </a:rPr>
              <a:t>Comparison of Coverage and Detected Single Nucletotide Variation</a:t>
            </a:r>
          </a:p>
        </c:rich>
      </c:tx>
      <c:layout>
        <c:manualLayout>
          <c:xMode val="edge"/>
          <c:yMode val="edge"/>
          <c:x val="0.19391128376652"/>
          <c:y val="1.5197568389057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charset="0"/>
              <a:ea typeface="Arial" charset="0"/>
              <a:cs typeface="Arial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868972397738599E-2"/>
          <c:y val="0.10009510223490301"/>
          <c:w val="0.78715717574134547"/>
          <c:h val="0.8120553315286369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heet1 (2)'!$D$1</c:f>
              <c:strCache>
                <c:ptCount val="1"/>
                <c:pt idx="0">
                  <c:v>Covera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Sheet1 (2)'!$A$2:$A$30</c:f>
              <c:strCache>
                <c:ptCount val="29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2A</c:v>
                </c:pt>
                <c:pt idx="4">
                  <c:v>2B</c:v>
                </c:pt>
                <c:pt idx="5">
                  <c:v>3A</c:v>
                </c:pt>
                <c:pt idx="6">
                  <c:v>4A</c:v>
                </c:pt>
                <c:pt idx="7">
                  <c:v>5A</c:v>
                </c:pt>
                <c:pt idx="8">
                  <c:v>5B</c:v>
                </c:pt>
                <c:pt idx="9">
                  <c:v>6A</c:v>
                </c:pt>
                <c:pt idx="10">
                  <c:v>7A</c:v>
                </c:pt>
                <c:pt idx="11">
                  <c:v>8A</c:v>
                </c:pt>
                <c:pt idx="12">
                  <c:v>9A</c:v>
                </c:pt>
                <c:pt idx="13">
                  <c:v>10A</c:v>
                </c:pt>
                <c:pt idx="14">
                  <c:v>10B</c:v>
                </c:pt>
                <c:pt idx="15">
                  <c:v>11A</c:v>
                </c:pt>
                <c:pt idx="16">
                  <c:v>12A</c:v>
                </c:pt>
                <c:pt idx="17">
                  <c:v>13A</c:v>
                </c:pt>
                <c:pt idx="18">
                  <c:v>14A</c:v>
                </c:pt>
                <c:pt idx="19">
                  <c:v>14B</c:v>
                </c:pt>
                <c:pt idx="20">
                  <c:v>14C</c:v>
                </c:pt>
                <c:pt idx="21">
                  <c:v>15A</c:v>
                </c:pt>
                <c:pt idx="22">
                  <c:v>16A</c:v>
                </c:pt>
                <c:pt idx="23">
                  <c:v>16B</c:v>
                </c:pt>
                <c:pt idx="24">
                  <c:v>17A</c:v>
                </c:pt>
                <c:pt idx="25">
                  <c:v>18A</c:v>
                </c:pt>
                <c:pt idx="26">
                  <c:v>19A</c:v>
                </c:pt>
                <c:pt idx="27">
                  <c:v>20A</c:v>
                </c:pt>
                <c:pt idx="28">
                  <c:v>21A</c:v>
                </c:pt>
              </c:strCache>
            </c:strRef>
          </c:cat>
          <c:val>
            <c:numRef>
              <c:f>'Sheet1 (2)'!$D$2:$D$30</c:f>
              <c:numCache>
                <c:formatCode>General</c:formatCode>
                <c:ptCount val="29"/>
                <c:pt idx="0">
                  <c:v>106.6</c:v>
                </c:pt>
                <c:pt idx="1">
                  <c:v>106.55</c:v>
                </c:pt>
                <c:pt idx="2">
                  <c:v>111.56</c:v>
                </c:pt>
                <c:pt idx="3">
                  <c:v>72.45</c:v>
                </c:pt>
                <c:pt idx="4">
                  <c:v>65.540000000000006</c:v>
                </c:pt>
                <c:pt idx="5">
                  <c:v>73.260000000000005</c:v>
                </c:pt>
                <c:pt idx="6">
                  <c:v>69.23</c:v>
                </c:pt>
                <c:pt idx="7">
                  <c:v>73.23</c:v>
                </c:pt>
                <c:pt idx="8">
                  <c:v>36.020000000000003</c:v>
                </c:pt>
                <c:pt idx="9">
                  <c:v>181.26</c:v>
                </c:pt>
                <c:pt idx="10">
                  <c:v>41.04</c:v>
                </c:pt>
                <c:pt idx="11">
                  <c:v>42.31</c:v>
                </c:pt>
                <c:pt idx="12">
                  <c:v>66.41</c:v>
                </c:pt>
                <c:pt idx="13">
                  <c:v>56.74</c:v>
                </c:pt>
                <c:pt idx="14">
                  <c:v>55.17</c:v>
                </c:pt>
                <c:pt idx="15">
                  <c:v>116.64</c:v>
                </c:pt>
                <c:pt idx="16">
                  <c:v>154.36000000000001</c:v>
                </c:pt>
                <c:pt idx="17">
                  <c:v>79.349999999999994</c:v>
                </c:pt>
                <c:pt idx="18">
                  <c:v>48.29</c:v>
                </c:pt>
                <c:pt idx="19">
                  <c:v>41.17</c:v>
                </c:pt>
                <c:pt idx="20">
                  <c:v>33.19</c:v>
                </c:pt>
                <c:pt idx="21">
                  <c:v>82.13</c:v>
                </c:pt>
                <c:pt idx="22">
                  <c:v>187.65</c:v>
                </c:pt>
                <c:pt idx="23">
                  <c:v>160.34</c:v>
                </c:pt>
                <c:pt idx="24">
                  <c:v>80.84</c:v>
                </c:pt>
                <c:pt idx="25">
                  <c:v>66.209999999999994</c:v>
                </c:pt>
                <c:pt idx="26">
                  <c:v>56.34</c:v>
                </c:pt>
                <c:pt idx="27">
                  <c:v>26.35</c:v>
                </c:pt>
                <c:pt idx="28">
                  <c:v>88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B3-8142-ACCE-6F54DF2F62DC}"/>
            </c:ext>
          </c:extLst>
        </c:ser>
        <c:ser>
          <c:idx val="1"/>
          <c:order val="1"/>
          <c:tx>
            <c:strRef>
              <c:f>'Sheet1 (2)'!$G$1</c:f>
              <c:strCache>
                <c:ptCount val="1"/>
                <c:pt idx="0">
                  <c:v>SNV Coun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heet1 (2)'!$A$2:$A$30</c:f>
              <c:strCache>
                <c:ptCount val="29"/>
                <c:pt idx="0">
                  <c:v>1A</c:v>
                </c:pt>
                <c:pt idx="1">
                  <c:v>1B</c:v>
                </c:pt>
                <c:pt idx="2">
                  <c:v>1C</c:v>
                </c:pt>
                <c:pt idx="3">
                  <c:v>2A</c:v>
                </c:pt>
                <c:pt idx="4">
                  <c:v>2B</c:v>
                </c:pt>
                <c:pt idx="5">
                  <c:v>3A</c:v>
                </c:pt>
                <c:pt idx="6">
                  <c:v>4A</c:v>
                </c:pt>
                <c:pt idx="7">
                  <c:v>5A</c:v>
                </c:pt>
                <c:pt idx="8">
                  <c:v>5B</c:v>
                </c:pt>
                <c:pt idx="9">
                  <c:v>6A</c:v>
                </c:pt>
                <c:pt idx="10">
                  <c:v>7A</c:v>
                </c:pt>
                <c:pt idx="11">
                  <c:v>8A</c:v>
                </c:pt>
                <c:pt idx="12">
                  <c:v>9A</c:v>
                </c:pt>
                <c:pt idx="13">
                  <c:v>10A</c:v>
                </c:pt>
                <c:pt idx="14">
                  <c:v>10B</c:v>
                </c:pt>
                <c:pt idx="15">
                  <c:v>11A</c:v>
                </c:pt>
                <c:pt idx="16">
                  <c:v>12A</c:v>
                </c:pt>
                <c:pt idx="17">
                  <c:v>13A</c:v>
                </c:pt>
                <c:pt idx="18">
                  <c:v>14A</c:v>
                </c:pt>
                <c:pt idx="19">
                  <c:v>14B</c:v>
                </c:pt>
                <c:pt idx="20">
                  <c:v>14C</c:v>
                </c:pt>
                <c:pt idx="21">
                  <c:v>15A</c:v>
                </c:pt>
                <c:pt idx="22">
                  <c:v>16A</c:v>
                </c:pt>
                <c:pt idx="23">
                  <c:v>16B</c:v>
                </c:pt>
                <c:pt idx="24">
                  <c:v>17A</c:v>
                </c:pt>
                <c:pt idx="25">
                  <c:v>18A</c:v>
                </c:pt>
                <c:pt idx="26">
                  <c:v>19A</c:v>
                </c:pt>
                <c:pt idx="27">
                  <c:v>20A</c:v>
                </c:pt>
                <c:pt idx="28">
                  <c:v>21A</c:v>
                </c:pt>
              </c:strCache>
            </c:strRef>
          </c:cat>
          <c:val>
            <c:numRef>
              <c:f>'Sheet1 (2)'!$G$2:$G$30</c:f>
              <c:numCache>
                <c:formatCode>General</c:formatCode>
                <c:ptCount val="29"/>
                <c:pt idx="0">
                  <c:v>-94</c:v>
                </c:pt>
                <c:pt idx="1">
                  <c:v>-94</c:v>
                </c:pt>
                <c:pt idx="2">
                  <c:v>-118</c:v>
                </c:pt>
                <c:pt idx="3">
                  <c:v>-64</c:v>
                </c:pt>
                <c:pt idx="4">
                  <c:v>-55</c:v>
                </c:pt>
                <c:pt idx="5">
                  <c:v>-84</c:v>
                </c:pt>
                <c:pt idx="6">
                  <c:v>-86</c:v>
                </c:pt>
                <c:pt idx="7">
                  <c:v>-77</c:v>
                </c:pt>
                <c:pt idx="8">
                  <c:v>-128</c:v>
                </c:pt>
                <c:pt idx="9">
                  <c:v>-202</c:v>
                </c:pt>
                <c:pt idx="10">
                  <c:v>-36</c:v>
                </c:pt>
                <c:pt idx="11">
                  <c:v>-45</c:v>
                </c:pt>
                <c:pt idx="12">
                  <c:v>-76</c:v>
                </c:pt>
                <c:pt idx="13">
                  <c:v>-65</c:v>
                </c:pt>
                <c:pt idx="14">
                  <c:v>-118</c:v>
                </c:pt>
                <c:pt idx="15">
                  <c:v>-200</c:v>
                </c:pt>
                <c:pt idx="16">
                  <c:v>-253</c:v>
                </c:pt>
                <c:pt idx="17">
                  <c:v>-82</c:v>
                </c:pt>
                <c:pt idx="18">
                  <c:v>-148</c:v>
                </c:pt>
                <c:pt idx="19">
                  <c:v>-157</c:v>
                </c:pt>
                <c:pt idx="20">
                  <c:v>-122</c:v>
                </c:pt>
                <c:pt idx="21">
                  <c:v>-127</c:v>
                </c:pt>
                <c:pt idx="22">
                  <c:v>-167</c:v>
                </c:pt>
                <c:pt idx="23">
                  <c:v>-148</c:v>
                </c:pt>
                <c:pt idx="24">
                  <c:v>-74</c:v>
                </c:pt>
                <c:pt idx="25">
                  <c:v>-103</c:v>
                </c:pt>
                <c:pt idx="26">
                  <c:v>-153</c:v>
                </c:pt>
                <c:pt idx="27">
                  <c:v>-82</c:v>
                </c:pt>
                <c:pt idx="28">
                  <c:v>-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B3-8142-ACCE-6F54DF2F62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4654272"/>
        <c:axId val="334656624"/>
      </c:barChart>
      <c:catAx>
        <c:axId val="334654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sz="900">
                    <a:solidFill>
                      <a:schemeClr val="tx1"/>
                    </a:solidFill>
                  </a:rPr>
                  <a:t>Sample Name</a:t>
                </a:r>
              </a:p>
            </c:rich>
          </c:tx>
          <c:layout>
            <c:manualLayout>
              <c:xMode val="edge"/>
              <c:yMode val="edge"/>
              <c:x val="0.8831891916289285"/>
              <c:y val="0.47773370752990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34656624"/>
        <c:crossesAt val="0"/>
        <c:auto val="1"/>
        <c:lblAlgn val="ctr"/>
        <c:lblOffset val="100"/>
        <c:noMultiLvlLbl val="0"/>
      </c:catAx>
      <c:valAx>
        <c:axId val="334656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Counts Reads/SNV</a:t>
                </a:r>
              </a:p>
            </c:rich>
          </c:tx>
          <c:layout>
            <c:manualLayout>
              <c:xMode val="edge"/>
              <c:yMode val="edge"/>
              <c:x val="2.6522033490303461E-2"/>
              <c:y val="0.354578005303515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34654272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75601101298388673"/>
          <c:y val="0.79632695504641759"/>
          <c:w val="0.11899334623411514"/>
          <c:h val="0.106764692416625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charset="0"/>
              <a:ea typeface="Arial" charset="0"/>
              <a:cs typeface="Arial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1.30928E-7</cdr:x>
      <cdr:y>1.87209E-7</cdr:y>
    </cdr:from>
    <cdr:to>
      <cdr:x>1.30928E-7</cdr:x>
      <cdr:y>1.87209E-7</cdr:y>
    </cdr:to>
    <cdr:grpSp>
      <cdr:nvGrpSpPr>
        <cdr:cNvPr id="4" name="Group 3">
          <a:extLst xmlns:a="http://schemas.openxmlformats.org/drawingml/2006/main">
            <a:ext uri="{FF2B5EF4-FFF2-40B4-BE49-F238E27FC236}">
              <a16:creationId xmlns:a16="http://schemas.microsoft.com/office/drawing/2014/main" id="{885DE26F-83FE-6D4F-AC91-3C3194A6991B}"/>
            </a:ext>
          </a:extLst>
        </cdr:cNvPr>
        <cdr:cNvGrpSpPr/>
      </cdr:nvGrpSpPr>
      <cdr:grpSpPr>
        <a:xfrm xmlns:a="http://schemas.openxmlformats.org/drawingml/2006/main">
          <a:off x="2" y="1"/>
          <a:ext cx="0" cy="0"/>
          <a:chOff x="2" y="1"/>
          <a:chExt cx="0" cy="0"/>
        </a:xfrm>
      </cdr:grpSpPr>
    </cdr:grpSp>
  </cdr:relSizeAnchor>
  <cdr:relSizeAnchor xmlns:cdr="http://schemas.openxmlformats.org/drawingml/2006/chartDrawing">
    <cdr:from>
      <cdr:x>0.04357</cdr:x>
      <cdr:y>0.52762</cdr:y>
    </cdr:from>
    <cdr:to>
      <cdr:x>0.05465</cdr:x>
      <cdr:y>0.9159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32776" y="2818364"/>
          <a:ext cx="84666" cy="2074334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05244</cdr:x>
      <cdr:y>0.53238</cdr:y>
    </cdr:from>
    <cdr:to>
      <cdr:x>0.06241</cdr:x>
      <cdr:y>0.57042</cdr:y>
    </cdr:to>
    <cdr:sp macro="" textlink="">
      <cdr:nvSpPr>
        <cdr:cNvPr id="5" name="TextBox 4"/>
        <cdr:cNvSpPr txBox="1"/>
      </cdr:nvSpPr>
      <cdr:spPr>
        <a:xfrm xmlns:a="http://schemas.openxmlformats.org/drawingml/2006/main" flipH="1">
          <a:off x="400508" y="2843764"/>
          <a:ext cx="76201" cy="2032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5938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95738" y="0"/>
            <a:ext cx="3055937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5601BB-F8EE-C34D-BEDF-DD54B1AC6B6E}" type="datetimeFigureOut">
              <a:rPr lang="en-US" smtClean="0"/>
              <a:t>12/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9988"/>
            <a:ext cx="5614987" cy="31575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4850" y="4502150"/>
            <a:ext cx="5643563" cy="36845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88413"/>
            <a:ext cx="3055938" cy="468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95738" y="8888413"/>
            <a:ext cx="3055937" cy="468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D296E0-E7C1-EF47-9005-724F1F9AE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229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307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130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651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09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85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40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238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64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801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968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416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51A90-1B8A-4F16-AE2B-4FA8E7CD2EB2}" type="datetimeFigureOut">
              <a:rPr lang="en-US" smtClean="0"/>
              <a:t>12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2CC1C-B7EF-4733-A6FC-79E7EB0EE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107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4381" y="2138766"/>
            <a:ext cx="10515600" cy="1261279"/>
          </a:xfrm>
        </p:spPr>
        <p:txBody>
          <a:bodyPr>
            <a:noAutofit/>
          </a:bodyPr>
          <a:lstStyle/>
          <a:p>
            <a:r>
              <a:rPr lang="en-US" sz="8800" dirty="0">
                <a:latin typeface="Phosphate Inline" charset="0"/>
                <a:ea typeface="Phosphate Inline" charset="0"/>
                <a:cs typeface="Phosphate Inline" charset="0"/>
              </a:rPr>
              <a:t>Supplemental</a:t>
            </a:r>
            <a:br>
              <a:rPr lang="en-US" sz="8800" dirty="0">
                <a:latin typeface="Phosphate Inline" charset="0"/>
                <a:ea typeface="Phosphate Inline" charset="0"/>
                <a:cs typeface="Phosphate Inline" charset="0"/>
              </a:rPr>
            </a:br>
            <a:r>
              <a:rPr lang="en-US" sz="8800" dirty="0">
                <a:latin typeface="Phosphate Inline" charset="0"/>
                <a:ea typeface="Phosphate Inline" charset="0"/>
                <a:cs typeface="Phosphate Inline" charset="0"/>
              </a:rPr>
              <a:t>Figures and Tables</a:t>
            </a:r>
          </a:p>
        </p:txBody>
      </p:sp>
    </p:spTree>
    <p:extLst>
      <p:ext uri="{BB962C8B-B14F-4D97-AF65-F5344CB8AC3E}">
        <p14:creationId xmlns:p14="http://schemas.microsoft.com/office/powerpoint/2010/main" val="962950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64724" y="112741"/>
            <a:ext cx="9744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1. Comparison of WES read depth (blue bars) and SNV frequency (orange bars).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0CBDFC4-2689-D044-9713-FDAB838E90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5402021"/>
              </p:ext>
            </p:extLst>
          </p:nvPr>
        </p:nvGraphicFramePr>
        <p:xfrm>
          <a:off x="824753" y="636494"/>
          <a:ext cx="11591365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759877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9557" y="420130"/>
            <a:ext cx="31756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Table 1</a:t>
            </a:r>
            <a:r>
              <a:rPr lang="en-US" dirty="0"/>
              <a:t>: Mutation Type Frequency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0294891"/>
              </p:ext>
            </p:extLst>
          </p:nvPr>
        </p:nvGraphicFramePr>
        <p:xfrm>
          <a:off x="4349749" y="2312194"/>
          <a:ext cx="4669601" cy="3378200"/>
        </p:xfrm>
        <a:graphic>
          <a:graphicData uri="http://schemas.openxmlformats.org/drawingml/2006/table">
            <a:tbl>
              <a:tblPr/>
              <a:tblGrid>
                <a:gridCol w="22555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140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711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utation Typ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utations in 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KIT-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utant GIST  </a:t>
                      </a: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(N=29 tumors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e_novo_Start_InFram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e_novo_Start_OutOfFram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Frame_Shift_D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Frame_Shift_I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n_Frame_D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n_Frame_I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ssense_Mut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2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nsense_Mut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nstop_Mut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ilent/Noncoding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18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ice_Sit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tart_Codon_D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tart_Codon_I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tart_Codon_SN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top_Codon_D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3537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965" y="236697"/>
            <a:ext cx="956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Table 2</a:t>
            </a:r>
            <a:r>
              <a:rPr lang="en-US" dirty="0"/>
              <a:t>. Breakdown of mutation rates per category discovered for this individual set.</a:t>
            </a: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C86B8EFB-6647-6847-8A4B-6BA2014D05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0066819"/>
              </p:ext>
            </p:extLst>
          </p:nvPr>
        </p:nvGraphicFramePr>
        <p:xfrm>
          <a:off x="2016310" y="2463987"/>
          <a:ext cx="5836771" cy="285792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81350">
                  <a:extLst>
                    <a:ext uri="{9D8B030D-6E8A-4147-A177-3AD203B41FA5}">
                      <a16:colId xmlns:a16="http://schemas.microsoft.com/office/drawing/2014/main" val="3141084904"/>
                    </a:ext>
                  </a:extLst>
                </a:gridCol>
                <a:gridCol w="924261">
                  <a:extLst>
                    <a:ext uri="{9D8B030D-6E8A-4147-A177-3AD203B41FA5}">
                      <a16:colId xmlns:a16="http://schemas.microsoft.com/office/drawing/2014/main" val="2996179027"/>
                    </a:ext>
                  </a:extLst>
                </a:gridCol>
                <a:gridCol w="1025550">
                  <a:extLst>
                    <a:ext uri="{9D8B030D-6E8A-4147-A177-3AD203B41FA5}">
                      <a16:colId xmlns:a16="http://schemas.microsoft.com/office/drawing/2014/main" val="3190253069"/>
                    </a:ext>
                  </a:extLst>
                </a:gridCol>
                <a:gridCol w="1101516">
                  <a:extLst>
                    <a:ext uri="{9D8B030D-6E8A-4147-A177-3AD203B41FA5}">
                      <a16:colId xmlns:a16="http://schemas.microsoft.com/office/drawing/2014/main" val="800147933"/>
                    </a:ext>
                  </a:extLst>
                </a:gridCol>
                <a:gridCol w="1304094">
                  <a:extLst>
                    <a:ext uri="{9D8B030D-6E8A-4147-A177-3AD203B41FA5}">
                      <a16:colId xmlns:a16="http://schemas.microsoft.com/office/drawing/2014/main" val="2885610295"/>
                    </a:ext>
                  </a:extLst>
                </a:gridCol>
              </a:tblGrid>
              <a:tr h="229267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Breakdown of mutation rates per category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580370"/>
                  </a:ext>
                </a:extLst>
              </a:tr>
              <a:tr h="229267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KIT mutant GISTS  (29 samples)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0346157"/>
                  </a:ext>
                </a:extLst>
              </a:tr>
              <a:tr h="4499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 dirty="0">
                          <a:effectLst/>
                        </a:rPr>
                        <a:t>Nam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Rate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Rate Per Mb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Relative Rat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Mutation Type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809053"/>
                  </a:ext>
                </a:extLst>
              </a:tr>
              <a:tr h="3707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 dirty="0">
                          <a:effectLst/>
                        </a:rPr>
                        <a:t>C</a:t>
                      </a:r>
                      <a:r>
                        <a:rPr lang="en-US" sz="16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G</a:t>
                      </a:r>
                      <a:r>
                        <a:rPr lang="en-US" sz="1600" u="none" strike="noStrike" dirty="0">
                          <a:effectLst/>
                        </a:rPr>
                        <a:t>-&gt;(A/T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.24E-0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.2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3.0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point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6582820"/>
                  </a:ext>
                </a:extLst>
              </a:tr>
              <a:tr h="3707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 dirty="0">
                          <a:effectLst/>
                        </a:rPr>
                        <a:t>C(</a:t>
                      </a:r>
                      <a:r>
                        <a:rPr lang="en-US" sz="16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A/C/T</a:t>
                      </a:r>
                      <a:r>
                        <a:rPr lang="en-US" sz="1600" u="none" strike="noStrike" dirty="0">
                          <a:effectLst/>
                        </a:rPr>
                        <a:t>)-&gt;(A/T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.55E-0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.5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.4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poin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36997"/>
                  </a:ext>
                </a:extLst>
              </a:tr>
              <a:tr h="3707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A-&gt;(C/G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8.21E-0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8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7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poin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6700416"/>
                  </a:ext>
                </a:extLst>
              </a:tr>
              <a:tr h="3707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flip codon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5.75E-0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5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5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poin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201273"/>
                  </a:ext>
                </a:extLst>
              </a:tr>
              <a:tr h="3707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null+inde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.35E-0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1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0.1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non-poin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44615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6334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4490" y="246637"/>
            <a:ext cx="408029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Table 3</a:t>
            </a:r>
            <a:r>
              <a:rPr lang="en-US" sz="1600" dirty="0"/>
              <a:t>: Regions of a large copy number variation affecting greater than 20% of the bases of a given chromosome arm. The numbers in the cells represent proportions of bases in the specified chromosomal arm that exhibit copy number variation</a:t>
            </a:r>
            <a:r>
              <a:rPr lang="en-US" sz="1600" dirty="0">
                <a:solidFill>
                  <a:srgbClr val="FF0000"/>
                </a:solidFill>
              </a:rPr>
              <a:t>.</a:t>
            </a:r>
            <a:endParaRPr lang="en-US" sz="1600" dirty="0"/>
          </a:p>
        </p:txBody>
      </p:sp>
      <p:sp>
        <p:nvSpPr>
          <p:cNvPr id="4" name="Rectangle 3"/>
          <p:cNvSpPr/>
          <p:nvPr/>
        </p:nvSpPr>
        <p:spPr>
          <a:xfrm>
            <a:off x="6001748" y="6071354"/>
            <a:ext cx="320792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C:\Users\Owner\Box Sync\</a:t>
            </a:r>
            <a:r>
              <a:rPr lang="en-US" sz="1050" dirty="0" err="1"/>
              <a:t>GIST_Analysis</a:t>
            </a:r>
            <a:r>
              <a:rPr lang="en-US" sz="1050" dirty="0"/>
              <a:t>\</a:t>
            </a:r>
            <a:r>
              <a:rPr lang="en-US" sz="1050" dirty="0" err="1"/>
              <a:t>CNV_Analysis</a:t>
            </a:r>
            <a:endParaRPr lang="en-US" sz="1050" dirty="0"/>
          </a:p>
        </p:txBody>
      </p:sp>
      <p:sp>
        <p:nvSpPr>
          <p:cNvPr id="9" name="TextBox 8"/>
          <p:cNvSpPr txBox="1"/>
          <p:nvPr/>
        </p:nvSpPr>
        <p:spPr>
          <a:xfrm>
            <a:off x="644491" y="1790868"/>
            <a:ext cx="1181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oss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88525" y="4489741"/>
            <a:ext cx="1181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ins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F42C3775-EFEA-DE4A-BF26-AC2BBF6689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0798455"/>
              </p:ext>
            </p:extLst>
          </p:nvPr>
        </p:nvGraphicFramePr>
        <p:xfrm>
          <a:off x="769805" y="2231349"/>
          <a:ext cx="10045983" cy="2084856"/>
        </p:xfrm>
        <a:graphic>
          <a:graphicData uri="http://schemas.openxmlformats.org/drawingml/2006/table">
            <a:tbl>
              <a:tblPr/>
              <a:tblGrid>
                <a:gridCol w="785993">
                  <a:extLst>
                    <a:ext uri="{9D8B030D-6E8A-4147-A177-3AD203B41FA5}">
                      <a16:colId xmlns:a16="http://schemas.microsoft.com/office/drawing/2014/main" val="82385291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028444922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86661052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47562390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467190479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263846929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07131361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351405800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04127135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731210001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373848239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337814479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632072254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924113217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743441147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220973737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206109528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641859565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428751973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039861171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083826474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4194084343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68580179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3464375006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809341217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562418625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690555794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790732690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1419408"/>
                    </a:ext>
                  </a:extLst>
                </a:gridCol>
                <a:gridCol w="319310">
                  <a:extLst>
                    <a:ext uri="{9D8B030D-6E8A-4147-A177-3AD203B41FA5}">
                      <a16:colId xmlns:a16="http://schemas.microsoft.com/office/drawing/2014/main" val="2905923781"/>
                    </a:ext>
                  </a:extLst>
                </a:gridCol>
              </a:tblGrid>
              <a:tr h="2788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identified ID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C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C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B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A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4994383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p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7593032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p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1559116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410722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52595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510073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p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8082528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8284441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0804159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9394793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6942537"/>
                  </a:ext>
                </a:extLst>
              </a:tr>
              <a:tr h="14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q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8</a:t>
                      </a:r>
                    </a:p>
                  </a:txBody>
                  <a:tcPr marL="8638" marR="8638" marT="86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7957354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9A493A62-30AE-4040-A06D-DF1C98D2DB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3937150"/>
              </p:ext>
            </p:extLst>
          </p:nvPr>
        </p:nvGraphicFramePr>
        <p:xfrm>
          <a:off x="769805" y="4889481"/>
          <a:ext cx="10045970" cy="1117140"/>
        </p:xfrm>
        <a:graphic>
          <a:graphicData uri="http://schemas.openxmlformats.org/drawingml/2006/table">
            <a:tbl>
              <a:tblPr/>
              <a:tblGrid>
                <a:gridCol w="748106">
                  <a:extLst>
                    <a:ext uri="{9D8B030D-6E8A-4147-A177-3AD203B41FA5}">
                      <a16:colId xmlns:a16="http://schemas.microsoft.com/office/drawing/2014/main" val="1909805096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991494856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616771709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498959121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530802960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595326578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616531593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138257587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917958392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4009957995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4283938387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85010823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06625878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568006852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624098367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68795341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815268507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110362880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179871966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591731592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792422823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4099711894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995956759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119005764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2910117139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4015301693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413117742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720251126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226800025"/>
                    </a:ext>
                  </a:extLst>
                </a:gridCol>
                <a:gridCol w="320616">
                  <a:extLst>
                    <a:ext uri="{9D8B030D-6E8A-4147-A177-3AD203B41FA5}">
                      <a16:colId xmlns:a16="http://schemas.microsoft.com/office/drawing/2014/main" val="3814234668"/>
                    </a:ext>
                  </a:extLst>
                </a:gridCol>
              </a:tblGrid>
              <a:tr h="29208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identified ID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C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C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B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A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751659"/>
                  </a:ext>
                </a:extLst>
              </a:tr>
              <a:tr h="149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p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692676"/>
                  </a:ext>
                </a:extLst>
              </a:tr>
              <a:tr h="149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q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960015"/>
                  </a:ext>
                </a:extLst>
              </a:tr>
              <a:tr h="149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q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407560"/>
                  </a:ext>
                </a:extLst>
              </a:tr>
              <a:tr h="149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q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3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1505440"/>
                  </a:ext>
                </a:extLst>
              </a:tr>
              <a:tr h="149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q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4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2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1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80808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8390" marR="8390" marT="8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44475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68089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489</TotalTime>
  <Words>830</Words>
  <Application>Microsoft Macintosh PowerPoint</Application>
  <PresentationFormat>Widescreen</PresentationFormat>
  <Paragraphs>61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hosphate Inline</vt:lpstr>
      <vt:lpstr>Office Theme</vt:lpstr>
      <vt:lpstr>Supplemental Figures and Tables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ice Patterson</dc:creator>
  <cp:lastModifiedBy>janice</cp:lastModifiedBy>
  <cp:revision>561</cp:revision>
  <cp:lastPrinted>2018-11-29T18:12:19Z</cp:lastPrinted>
  <dcterms:created xsi:type="dcterms:W3CDTF">2016-01-05T19:43:36Z</dcterms:created>
  <dcterms:modified xsi:type="dcterms:W3CDTF">2018-12-10T03:32:30Z</dcterms:modified>
</cp:coreProperties>
</file>